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0" r:id="rId3"/>
    <p:sldId id="257" r:id="rId4"/>
    <p:sldId id="263" r:id="rId5"/>
    <p:sldId id="264" r:id="rId6"/>
    <p:sldId id="265" r:id="rId7"/>
    <p:sldId id="266" r:id="rId8"/>
    <p:sldId id="267" r:id="rId9"/>
    <p:sldId id="268" r:id="rId10"/>
    <p:sldId id="269" r:id="rId11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FF0000"/>
    <a:srgbClr val="0000FA"/>
    <a:srgbClr val="0000FF"/>
    <a:srgbClr val="0000FD"/>
    <a:srgbClr val="0000F0"/>
    <a:srgbClr val="0000D2"/>
    <a:srgbClr val="CCECFF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44" autoAdjust="0"/>
    <p:restoredTop sz="94650" autoAdjust="0"/>
  </p:normalViewPr>
  <p:slideViewPr>
    <p:cSldViewPr snapToGrid="0">
      <p:cViewPr>
        <p:scale>
          <a:sx n="100" d="100"/>
          <a:sy n="100" d="100"/>
        </p:scale>
        <p:origin x="-1212" y="-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B3DC44-3A81-4622-8B4E-DB36F00F9D3D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149ABE-8A4D-4EA9-9E86-FC2EFBA4DA6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3E19AD-19E9-46FD-92D0-CDC5DF4B13DF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16CB71-2053-4E9E-A4B6-B8448AF374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40A079-ABAE-40BD-8134-9C0F7AE4018E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EFDA44-41BC-41FF-BD1E-15E4400F05E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7BA30B-7EC5-431E-868B-DF8D9C8F0FC7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0E3304-2CB6-4AC7-B393-5D44FEA6F4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844A56-6853-42BA-8E87-E7FDF659B290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C9108A-71CA-418A-871B-7850B06A4D2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DD68EA-2C4C-43AC-8F1B-9D6CF6795D32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0EE07A-72D6-47FB-A457-077B61451F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851267-6282-4D15-9FD4-877A4EB9FD54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56BA78-EAA2-4C1F-BE48-B33E3A58BBC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08670D-FBBC-4B53-A57A-154AD3CECF91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8D9D61-0232-48BB-AD89-DDC68FBE59B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08F976-A149-42FE-8787-6C32CC686793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BEA993-FB85-4841-BF6E-38981E1CC7D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3DFDAB-AEA2-4CC4-9C81-B62682F57671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0417E1-7142-447E-885A-8FE4F087E83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082626-8B2C-43E5-ADF1-C270DA70FB3A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AAB43B-AFB6-49F4-8F58-3005A919BB8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CCEC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AEB15DF-1B6B-448B-8B08-88F61D493846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5B0C1923-9552-46A0-BCFD-3CA9292C33C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114300" y="238125"/>
            <a:ext cx="1009650" cy="16192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960479" y="0"/>
            <a:ext cx="31855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red </a:t>
            </a:r>
            <a:r>
              <a:rPr lang="en-US" dirty="0" smtClean="0"/>
              <a:t>bar - red </a:t>
            </a:r>
            <a:r>
              <a:rPr lang="en-US" dirty="0" smtClean="0"/>
              <a:t>bar, </a:t>
            </a:r>
            <a:r>
              <a:rPr lang="en-US" dirty="0" smtClean="0"/>
              <a:t>4x </a:t>
            </a:r>
            <a:r>
              <a:rPr lang="en-US" dirty="0" smtClean="0"/>
              <a:t>repeated</a:t>
            </a:r>
            <a:endParaRPr lang="en-US" dirty="0"/>
          </a:p>
        </p:txBody>
      </p:sp>
    </p:spTree>
  </p:cSld>
  <p:clrMapOvr>
    <a:masterClrMapping/>
  </p:clrMapOvr>
  <p:transition advClick="0" advTm="6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5" presetClass="path" presetSubtype="0" repeatCount="indefinite" autoRev="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7708 2.22222E-6 L 1.66667E-6 2.22222E-6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3854" y="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 animBg="1"/>
    </p:bld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65881" y="2967039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629150" y="2967039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65881" y="5999163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29150" y="5999163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4181475" y="0"/>
            <a:ext cx="800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10 min</a:t>
            </a:r>
            <a:endParaRPr lang="en-US" sz="1600" dirty="0"/>
          </a:p>
        </p:txBody>
      </p:sp>
    </p:spTree>
    <p:extLst>
      <p:ext uri="{BB962C8B-B14F-4D97-AF65-F5344CB8AC3E}">
        <p14:creationId xmlns="" xmlns:p14="http://schemas.microsoft.com/office/powerpoint/2010/main" val="92198341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0 L 1.66667E-6 -0.14306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7153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61111E-6 -2.22222E-6 L -0.00105 -0.14583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52" y="-7292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61111E-6 -1.85185E-6 L 3.61111E-6 -0.13055 " pathEditMode="relative" rAng="0" ptsTypes="AA">
                                      <p:cBhvr>
                                        <p:cTn id="10" dur="20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6528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-1.85185E-6 L 1.66667E-6 -0.13055 " pathEditMode="relative" rAng="0" ptsTypes="AA">
                                      <p:cBhvr>
                                        <p:cTn id="12" dur="2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6528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animBg="1"/>
      <p:bldP spid="27" grpId="0" animBg="1"/>
      <p:bldP spid="28" grpId="0" animBg="1"/>
      <p:bldP spid="29" grpId="0" animBg="1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4181475" y="0"/>
            <a:ext cx="800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20 min</a:t>
            </a:r>
            <a:endParaRPr lang="en-US" sz="1600" dirty="0"/>
          </a:p>
        </p:txBody>
      </p:sp>
    </p:spTree>
  </p:cSld>
  <p:clrMapOvr>
    <a:masterClrMapping/>
  </p:clrMapOvr>
  <p:transition advClick="0" advTm="1200000"/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66675" y="485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629150" y="485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66675" y="3533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29150" y="3533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4181475" y="0"/>
            <a:ext cx="800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10 min</a:t>
            </a:r>
            <a:endParaRPr lang="en-US" sz="1600" dirty="0"/>
          </a:p>
        </p:txBody>
      </p:sp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3.33333E-6 L 1.66667E-6 0.14583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3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3.33333E-6 L 0 0.14722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4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-1.11111E-6 L 0 0.14028 " pathEditMode="relative" rAng="0" ptsTypes="AA">
                                      <p:cBhvr>
                                        <p:cTn id="10" dur="20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-1.11111E-6 L 1.66667E-6 0.14028 " pathEditMode="relative" rAng="0" ptsTypes="AA">
                                      <p:cBhvr>
                                        <p:cTn id="12" dur="2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animBg="1"/>
      <p:bldP spid="27" grpId="0" animBg="1"/>
      <p:bldP spid="28" grpId="0" animBg="1"/>
      <p:bldP spid="29" grpId="0" animBg="1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65881" y="2967039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629150" y="2967039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65881" y="5999163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29150" y="5999163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4181475" y="0"/>
            <a:ext cx="800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10 min</a:t>
            </a:r>
            <a:endParaRPr lang="en-US" sz="1600" dirty="0"/>
          </a:p>
        </p:txBody>
      </p:sp>
    </p:spTree>
    <p:extLst>
      <p:ext uri="{BB962C8B-B14F-4D97-AF65-F5344CB8AC3E}">
        <p14:creationId xmlns="" xmlns:p14="http://schemas.microsoft.com/office/powerpoint/2010/main" val="92198341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0 L 1.66667E-6 -0.14306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7153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61111E-6 -2.22222E-6 L -0.00105 -0.14583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52" y="-7292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61111E-6 -1.85185E-6 L 3.61111E-6 -0.13055 " pathEditMode="relative" rAng="0" ptsTypes="AA">
                                      <p:cBhvr>
                                        <p:cTn id="10" dur="20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6528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-1.85185E-6 L 1.66667E-6 -0.13055 " pathEditMode="relative" rAng="0" ptsTypes="AA">
                                      <p:cBhvr>
                                        <p:cTn id="12" dur="2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6528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animBg="1"/>
      <p:bldP spid="27" grpId="0" animBg="1"/>
      <p:bldP spid="28" grpId="0" animBg="1"/>
      <p:bldP spid="29" grpId="0" animBg="1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66675" y="485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629150" y="485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66675" y="3533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29150" y="3533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4181475" y="0"/>
            <a:ext cx="800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10 min</a:t>
            </a:r>
            <a:endParaRPr lang="en-US" sz="1600" dirty="0"/>
          </a:p>
        </p:txBody>
      </p:sp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3.33333E-6 L 1.66667E-6 0.14583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3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3.33333E-6 L 0 0.14722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4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-1.11111E-6 L 0 0.14028 " pathEditMode="relative" rAng="0" ptsTypes="AA">
                                      <p:cBhvr>
                                        <p:cTn id="10" dur="20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-1.11111E-6 L 1.66667E-6 0.14028 " pathEditMode="relative" rAng="0" ptsTypes="AA">
                                      <p:cBhvr>
                                        <p:cTn id="12" dur="2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animBg="1"/>
      <p:bldP spid="27" grpId="0" animBg="1"/>
      <p:bldP spid="28" grpId="0" animBg="1"/>
      <p:bldP spid="29" grpId="0" animBg="1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65881" y="2967039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629150" y="2967039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65881" y="5999163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29150" y="5999163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4181475" y="0"/>
            <a:ext cx="800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10 min</a:t>
            </a:r>
            <a:endParaRPr lang="en-US" sz="1600" dirty="0"/>
          </a:p>
        </p:txBody>
      </p:sp>
    </p:spTree>
    <p:extLst>
      <p:ext uri="{BB962C8B-B14F-4D97-AF65-F5344CB8AC3E}">
        <p14:creationId xmlns="" xmlns:p14="http://schemas.microsoft.com/office/powerpoint/2010/main" val="92198341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0 L 1.66667E-6 -0.14306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7153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61111E-6 -2.22222E-6 L -0.00105 -0.14583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52" y="-7292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61111E-6 -1.85185E-6 L 3.61111E-6 -0.13055 " pathEditMode="relative" rAng="0" ptsTypes="AA">
                                      <p:cBhvr>
                                        <p:cTn id="10" dur="20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6528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-1.85185E-6 L 1.66667E-6 -0.13055 " pathEditMode="relative" rAng="0" ptsTypes="AA">
                                      <p:cBhvr>
                                        <p:cTn id="12" dur="2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6528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animBg="1"/>
      <p:bldP spid="27" grpId="0" animBg="1"/>
      <p:bldP spid="28" grpId="0" animBg="1"/>
      <p:bldP spid="29" grpId="0" animBg="1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66675" y="485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629150" y="485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66675" y="3533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29150" y="3533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4181475" y="0"/>
            <a:ext cx="800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10 min</a:t>
            </a:r>
            <a:endParaRPr lang="en-US" sz="1600" dirty="0"/>
          </a:p>
        </p:txBody>
      </p:sp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3.33333E-6 L 1.66667E-6 0.14583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3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3.33333E-6 L 0 0.14722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4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-1.11111E-6 L 0 0.14028 " pathEditMode="relative" rAng="0" ptsTypes="AA">
                                      <p:cBhvr>
                                        <p:cTn id="10" dur="20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-1.11111E-6 L 1.66667E-6 0.14028 " pathEditMode="relative" rAng="0" ptsTypes="AA">
                                      <p:cBhvr>
                                        <p:cTn id="12" dur="2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animBg="1"/>
      <p:bldP spid="27" grpId="0" animBg="1"/>
      <p:bldP spid="28" grpId="0" animBg="1"/>
      <p:bldP spid="29" grpId="0" animBg="1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65881" y="2967039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629150" y="2967039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65881" y="5999163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29150" y="5999163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4181475" y="0"/>
            <a:ext cx="800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10 min</a:t>
            </a:r>
            <a:endParaRPr lang="en-US" sz="1600" dirty="0"/>
          </a:p>
        </p:txBody>
      </p:sp>
    </p:spTree>
    <p:extLst>
      <p:ext uri="{BB962C8B-B14F-4D97-AF65-F5344CB8AC3E}">
        <p14:creationId xmlns="" xmlns:p14="http://schemas.microsoft.com/office/powerpoint/2010/main" val="92198341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0 L 1.66667E-6 -0.14306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7153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61111E-6 -2.22222E-6 L -0.00105 -0.14583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52" y="-7292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61111E-6 -1.85185E-6 L 3.61111E-6 -0.13055 " pathEditMode="relative" rAng="0" ptsTypes="AA">
                                      <p:cBhvr>
                                        <p:cTn id="10" dur="20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6528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-1.85185E-6 L 1.66667E-6 -0.13055 " pathEditMode="relative" rAng="0" ptsTypes="AA">
                                      <p:cBhvr>
                                        <p:cTn id="12" dur="2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6528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animBg="1"/>
      <p:bldP spid="27" grpId="0" animBg="1"/>
      <p:bldP spid="28" grpId="0" animBg="1"/>
      <p:bldP spid="29" grpId="0" animBg="1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66675" y="485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629150" y="485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66675" y="3533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29150" y="3533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4181475" y="0"/>
            <a:ext cx="800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10 min</a:t>
            </a:r>
            <a:endParaRPr lang="en-US" sz="1600" dirty="0"/>
          </a:p>
        </p:txBody>
      </p:sp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3.33333E-6 L 1.66667E-6 0.14583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3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3.33333E-6 L 0 0.14722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4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-1.11111E-6 L 0 0.14028 " pathEditMode="relative" rAng="0" ptsTypes="AA">
                                      <p:cBhvr>
                                        <p:cTn id="10" dur="20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-1.11111E-6 L 1.66667E-6 0.14028 " pathEditMode="relative" rAng="0" ptsTypes="AA">
                                      <p:cBhvr>
                                        <p:cTn id="12" dur="2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animBg="1"/>
      <p:bldP spid="27" grpId="0" animBg="1"/>
      <p:bldP spid="28" grpId="0" animBg="1"/>
      <p:bldP spid="29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61</TotalTime>
  <Words>26</Words>
  <Application>Microsoft Office PowerPoint</Application>
  <PresentationFormat>On-screen Show (4:3)</PresentationFormat>
  <Paragraphs>10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</vt:vector>
  </TitlesOfParts>
  <Company>Brown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bbert</dc:creator>
  <cp:lastModifiedBy>Robbert</cp:lastModifiedBy>
  <cp:revision>100</cp:revision>
  <dcterms:created xsi:type="dcterms:W3CDTF">2010-02-15T14:38:38Z</dcterms:created>
  <dcterms:modified xsi:type="dcterms:W3CDTF">2017-01-28T16:51:50Z</dcterms:modified>
</cp:coreProperties>
</file>